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Override1.xml" ContentType="application/vnd.openxmlformats-officedocument.themeOverride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62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88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tges, Cornelia" initials="MC" lastIdx="1" clrIdx="0">
    <p:extLst>
      <p:ext uri="{19B8F6BF-5375-455C-9EA6-DF929625EA0E}">
        <p15:presenceInfo xmlns:p15="http://schemas.microsoft.com/office/powerpoint/2012/main" userId="S-1-5-21-503454387-1949045944-1556899496-1647" providerId="AD"/>
      </p:ext>
    </p:extLst>
  </p:cmAuthor>
  <p:cmAuthor id="2" name="Seyedalmossavi, Seyed Mohammadmahdi" initials="SSM" lastIdx="1" clrIdx="1">
    <p:extLst>
      <p:ext uri="{19B8F6BF-5375-455C-9EA6-DF929625EA0E}">
        <p15:presenceInfo xmlns:p15="http://schemas.microsoft.com/office/powerpoint/2012/main" userId="Seyedalmossavi, Seyed Mohammadmahd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AF2"/>
    <a:srgbClr val="7AF2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2496" y="102"/>
      </p:cViewPr>
      <p:guideLst>
        <p:guide orient="horz" pos="2160"/>
        <p:guide pos="2880"/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CCA6D-885C-46BE-99B6-D7BE0AA3ADCF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396086-4DF5-4C1A-9383-489DF13016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785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Master" Target="../slideMasters/slideMaster1.xml"/><Relationship Id="rId1" Type="http://schemas.openxmlformats.org/officeDocument/2006/relationships/themeOverride" Target="../theme/themeOverride1.xml"/><Relationship Id="rId4" Type="http://schemas.openxmlformats.org/officeDocument/2006/relationships/image" Target="../media/image2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88362D-1D0C-4593-A9CA-02F6DE5E30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114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05C50B-E0C3-4BF6-8544-A9C566FA299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275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3C7264-A86D-4D82-B02E-BD7B43AA23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8682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2"/>
          <p:cNvSpPr>
            <a:spLocks noChangeArrowheads="1"/>
          </p:cNvSpPr>
          <p:nvPr userDrawn="1"/>
        </p:nvSpPr>
        <p:spPr bwMode="auto">
          <a:xfrm>
            <a:off x="0" y="6972301"/>
            <a:ext cx="6858000" cy="2171700"/>
          </a:xfrm>
          <a:prstGeom prst="rect">
            <a:avLst/>
          </a:prstGeom>
          <a:solidFill>
            <a:schemeClr val="accent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de-DE" altLang="de-DE" smtClean="0">
              <a:solidFill>
                <a:srgbClr val="1A1A1A"/>
              </a:solidFill>
              <a:cs typeface="+mn-cs"/>
            </a:endParaRPr>
          </a:p>
        </p:txBody>
      </p:sp>
      <p:pic>
        <p:nvPicPr>
          <p:cNvPr id="3" name="Picture 14" descr="Startfolie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478366"/>
            <a:ext cx="6872288" cy="7429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16" descr="Logo ws_eng"/>
          <p:cNvPicPr>
            <a:picLocks noChangeAspect="1" noChangeArrowheads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391" y="7391400"/>
            <a:ext cx="2909888" cy="12805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4288649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CC6F7-0F91-4441-BF97-A3AF72A4830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18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A0F213-BB88-4223-AECB-E7C98DE4F9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750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5F555C-B798-4584-9735-0D743CA03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326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78F460-E66C-4863-AF15-C4A2426FA0F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766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22F1AA-6A28-4DC7-B08E-B0B6C826795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467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9ED24E-8843-4C3A-ACB3-45594BD874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03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017539-FB6A-4BCE-86F3-A1A36D15902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958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79D9DB-D59E-4BB7-A5D4-1AE4FF1B3F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16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6834"/>
            <a:ext cx="5915025" cy="17674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ext styles</a:t>
            </a:r>
          </a:p>
          <a:p>
            <a:pPr lvl="1"/>
            <a:r>
              <a:rPr lang="en-US" altLang="de-DE" smtClean="0"/>
              <a:t>Second level</a:t>
            </a:r>
          </a:p>
          <a:p>
            <a:pPr lvl="2"/>
            <a:r>
              <a:rPr lang="en-US" altLang="de-DE" smtClean="0"/>
              <a:t>Third level</a:t>
            </a:r>
          </a:p>
          <a:p>
            <a:pPr lvl="3"/>
            <a:r>
              <a:rPr lang="en-US" altLang="de-DE" smtClean="0"/>
              <a:t>Fourth level</a:t>
            </a:r>
          </a:p>
          <a:p>
            <a:pPr lvl="4"/>
            <a:r>
              <a:rPr lang="en-US" altLang="de-DE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C841DE4-B32F-40E3-9F96-C2C98F208100}" type="datetime1">
              <a:rPr lang="en-US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DB8A7E9-E4BA-4136-A86B-FC9378F0562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hf hdr="0" ftr="0" dt="0"/>
  <p:txStyles>
    <p:titleStyle>
      <a:lvl1pPr algn="l" rtl="0" fontAlgn="base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2pPr>
      <a:lvl3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3pPr>
      <a:lvl4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4pPr>
      <a:lvl5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9pPr>
    </p:titleStyle>
    <p:bodyStyle>
      <a:lvl1pPr marL="228600" indent="-228600" algn="l" rtl="0" fontAlgn="base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4"/>
          <p:cNvSpPr/>
          <p:nvPr/>
        </p:nvSpPr>
        <p:spPr>
          <a:xfrm>
            <a:off x="-63960" y="8462173"/>
            <a:ext cx="69847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increasing levels of black soldier fly in broiler rations on crude protein intake  (A) crude fat intake (B)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zabl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erg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ake 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ing the experimental weeks. N = 144 (4 treatments each with 6 replicate pens measured at 6 weeks)(n = 6 per group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LSM with their 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219" y="35496"/>
            <a:ext cx="6468417" cy="8388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410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">
    <a:dk1>
      <a:srgbClr val="1A1A1A"/>
    </a:dk1>
    <a:lt1>
      <a:srgbClr val="FFFFFF"/>
    </a:lt1>
    <a:dk2>
      <a:srgbClr val="1A1A1A"/>
    </a:dk2>
    <a:lt2>
      <a:srgbClr val="FFFFFF"/>
    </a:lt2>
    <a:accent1>
      <a:srgbClr val="00447A"/>
    </a:accent1>
    <a:accent2>
      <a:srgbClr val="00B000"/>
    </a:accent2>
    <a:accent3>
      <a:srgbClr val="FFFFFF"/>
    </a:accent3>
    <a:accent4>
      <a:srgbClr val="141414"/>
    </a:accent4>
    <a:accent5>
      <a:srgbClr val="AAB0BE"/>
    </a:accent5>
    <a:accent6>
      <a:srgbClr val="009F00"/>
    </a:accent6>
    <a:hlink>
      <a:srgbClr val="66CCFF"/>
    </a:hlink>
    <a:folHlink>
      <a:srgbClr val="FFE701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Leibniz-Institut für Nutztierbiologie (FBN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yedalmossavi, Seyed Mohammadmahdi</dc:creator>
  <cp:lastModifiedBy>Seyedalmoosavi, Seyed Mohammadmahdi</cp:lastModifiedBy>
  <cp:revision>157</cp:revision>
  <cp:lastPrinted>2022-01-18T09:07:24Z</cp:lastPrinted>
  <dcterms:created xsi:type="dcterms:W3CDTF">2021-11-10T16:13:10Z</dcterms:created>
  <dcterms:modified xsi:type="dcterms:W3CDTF">2022-07-13T13:10:45Z</dcterms:modified>
</cp:coreProperties>
</file>